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37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20" userDrawn="1">
          <p15:clr>
            <a:srgbClr val="A4A3A4"/>
          </p15:clr>
        </p15:guide>
        <p15:guide id="2" pos="34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Zheng, Zhi-Ming (Thomas) (NIH/NCI) [E]" initials="ZZ(([" lastIdx="25" clrIdx="0"/>
  <p:cmAuthor id="1" name="袁菲" initials="袁菲" lastIdx="13" clrIdx="1">
    <p:extLst/>
  </p:cmAuthor>
  <p:cmAuthor id="2" name="袁 菲" initials="袁" lastIdx="15" clrIdx="2">
    <p:extLst/>
  </p:cmAuthor>
  <p:cmAuthor id="3" name="xp26 x" initials="xx" lastIdx="6" clrIdx="3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7647" autoAdjust="0"/>
    <p:restoredTop sz="86486" autoAdjust="0"/>
  </p:normalViewPr>
  <p:slideViewPr>
    <p:cSldViewPr snapToGrid="0">
      <p:cViewPr varScale="1">
        <p:scale>
          <a:sx n="48" d="100"/>
          <a:sy n="48" d="100"/>
        </p:scale>
        <p:origin x="2682" y="60"/>
      </p:cViewPr>
      <p:guideLst>
        <p:guide orient="horz" pos="1020"/>
        <p:guide pos="34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3673C9-9B0D-43B3-B951-1801E97726B6}" type="datetimeFigureOut">
              <a:rPr lang="zh-CN" altLang="en-US" smtClean="0"/>
              <a:t>2018/7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9A8904-E1A2-4127-A262-D0608E6F2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652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D9A8904-E1A2-4127-A262-D0608E6F232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40027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402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867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857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965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59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309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332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03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113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2123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046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366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453223" y="6250576"/>
            <a:ext cx="5923722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000" b="1" dirty="0">
                <a:latin typeface="Arial" panose="020B0604020202020204" pitchFamily="34" charset="0"/>
                <a:cs typeface="宋体" panose="02010600030101010101" pitchFamily="2" charset="-122"/>
              </a:rPr>
              <a:t>Supplemental Figure S3. The clustered hydrophobic residues in the N-terminal arm (A) and C-terminal end (B) of ORF57-CTD. </a:t>
            </a:r>
            <a:endParaRPr lang="zh-CN" altLang="zh-CN" sz="1200" dirty="0"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  <a:p>
            <a:pPr>
              <a:spcAft>
                <a:spcPts val="0"/>
              </a:spcAft>
            </a:pP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(A) The residues in N-terminal arm in a stick model display hydrophobicity in scaled color in </a:t>
            </a:r>
            <a:r>
              <a:rPr lang="en-US" altLang="zh-CN" sz="1000" dirty="0" err="1">
                <a:latin typeface="Arial" panose="020B0604020202020204" pitchFamily="34" charset="0"/>
                <a:cs typeface="宋体" panose="02010600030101010101" pitchFamily="2" charset="-122"/>
              </a:rPr>
              <a:t>PyMol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 scripts, with the highly hydrophobic residues labeled in black letters. (B) The C-terminal end is rich in hydrophobic residues in scaled color by </a:t>
            </a:r>
            <a:r>
              <a:rPr lang="en-US" altLang="zh-CN" sz="1000" dirty="0" err="1">
                <a:latin typeface="Arial" panose="020B0604020202020204" pitchFamily="34" charset="0"/>
                <a:cs typeface="宋体" panose="02010600030101010101" pitchFamily="2" charset="-122"/>
              </a:rPr>
              <a:t>PyMol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 scripts. The interactions between the hydrophobic C-terminal end (black) and the surrounding residues (green) are shown in black dash lines with the distances between the interacting atoms showed in in Å. </a:t>
            </a:r>
            <a:endParaRPr lang="zh-CN" alt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35"/>
          <a:stretch/>
        </p:blipFill>
        <p:spPr>
          <a:xfrm>
            <a:off x="1528923" y="389694"/>
            <a:ext cx="3683694" cy="2698967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2683" y="3401846"/>
            <a:ext cx="3082517" cy="2549133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1593960" y="389694"/>
            <a:ext cx="533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692683" y="3423945"/>
            <a:ext cx="5336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58928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794</TotalTime>
  <Words>111</Words>
  <Application>Microsoft Office PowerPoint</Application>
  <PresentationFormat>全屏显示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宋体</vt:lpstr>
      <vt:lpstr>Arial</vt:lpstr>
      <vt:lpstr>Calibri</vt:lpstr>
      <vt:lpstr>Calibri Light</vt:lpstr>
      <vt:lpstr>Office Theme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jerciak, Vladimir (NIH/NCI) [E]</dc:creator>
  <cp:lastModifiedBy>袁 菲</cp:lastModifiedBy>
  <cp:revision>1430</cp:revision>
  <cp:lastPrinted>2018-01-18T18:33:05Z</cp:lastPrinted>
  <dcterms:created xsi:type="dcterms:W3CDTF">2017-06-08T22:39:00Z</dcterms:created>
  <dcterms:modified xsi:type="dcterms:W3CDTF">2018-07-26T12:42:26Z</dcterms:modified>
</cp:coreProperties>
</file>